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7169150" cy="2057400"/>
  <p:notesSz cx="6858000" cy="9144000"/>
  <p:defaultTextStyle>
    <a:defPPr>
      <a:defRPr lang="en-US"/>
    </a:defPPr>
    <a:lvl1pPr marL="0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1pPr>
    <a:lvl2pPr marL="270114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2pPr>
    <a:lvl3pPr marL="540228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3pPr>
    <a:lvl4pPr marL="810341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4pPr>
    <a:lvl5pPr marL="1080455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5pPr>
    <a:lvl6pPr marL="1350569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6pPr>
    <a:lvl7pPr marL="1620683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7pPr>
    <a:lvl8pPr marL="1890796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8pPr>
    <a:lvl9pPr marL="2160910" algn="l" defTabSz="540228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8" userDrawn="1">
          <p15:clr>
            <a:srgbClr val="A4A3A4"/>
          </p15:clr>
        </p15:guide>
        <p15:guide id="2" pos="22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99" autoAdjust="0"/>
  </p:normalViewPr>
  <p:slideViewPr>
    <p:cSldViewPr>
      <p:cViewPr>
        <p:scale>
          <a:sx n="100" d="100"/>
          <a:sy n="100" d="100"/>
        </p:scale>
        <p:origin x="920" y="860"/>
      </p:cViewPr>
      <p:guideLst>
        <p:guide orient="horz" pos="648"/>
        <p:guide pos="22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0E4FE6-312F-49CF-B6B4-95F4DE7DD6ED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2544763" y="685800"/>
            <a:ext cx="11947526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6125B6-E327-4FA8-BBCE-503EC29803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457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1pPr>
    <a:lvl2pPr marL="270114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2pPr>
    <a:lvl3pPr marL="540228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3pPr>
    <a:lvl4pPr marL="810341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4pPr>
    <a:lvl5pPr marL="1080455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5pPr>
    <a:lvl6pPr marL="1350569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6pPr>
    <a:lvl7pPr marL="1620683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7pPr>
    <a:lvl8pPr marL="1890796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8pPr>
    <a:lvl9pPr marL="2160910" algn="l" defTabSz="54022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2544763" y="685800"/>
            <a:ext cx="11947526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6125B6-E327-4FA8-BBCE-503EC29803E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389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7686" y="639128"/>
            <a:ext cx="6093778" cy="44100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5374" y="1165860"/>
            <a:ext cx="5018405" cy="5257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153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339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97635" y="82392"/>
            <a:ext cx="1613059" cy="175545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458" y="82392"/>
            <a:ext cx="4719690" cy="175545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565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63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313" y="1322071"/>
            <a:ext cx="6093778" cy="40862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313" y="872014"/>
            <a:ext cx="6093778" cy="45005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676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458" y="480060"/>
            <a:ext cx="3166375" cy="13577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319" y="480060"/>
            <a:ext cx="3166375" cy="13577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64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457" y="460533"/>
            <a:ext cx="3167620" cy="19192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8457" y="652462"/>
            <a:ext cx="3167620" cy="11853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1829" y="460533"/>
            <a:ext cx="3168864" cy="19192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1829" y="652462"/>
            <a:ext cx="3168864" cy="11853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80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356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568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9" y="81915"/>
            <a:ext cx="2358601" cy="34861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2939" y="81915"/>
            <a:ext cx="4007754" cy="175593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9" y="430530"/>
            <a:ext cx="2358601" cy="14073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019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5204" y="1440180"/>
            <a:ext cx="4301490" cy="1700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05204" y="183832"/>
            <a:ext cx="4301490" cy="1234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5204" y="1610202"/>
            <a:ext cx="4301490" cy="2414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364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459" y="82391"/>
            <a:ext cx="6452235" cy="3429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459" y="480060"/>
            <a:ext cx="6452235" cy="13577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457" y="1906906"/>
            <a:ext cx="1672802" cy="1095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CEE866-1F40-421B-9EFE-6F71C15DDC26}" type="datetimeFigureOut">
              <a:rPr lang="en-US" smtClean="0"/>
              <a:t>7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49461" y="1906906"/>
            <a:ext cx="2270231" cy="1095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37891" y="1906906"/>
            <a:ext cx="1672802" cy="1095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078F5-FE46-4C59-8471-E755E1985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541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4293195"/>
              </p:ext>
            </p:extLst>
          </p:nvPr>
        </p:nvGraphicFramePr>
        <p:xfrm>
          <a:off x="79375" y="114300"/>
          <a:ext cx="7010400" cy="1757172"/>
        </p:xfrm>
        <a:graphic>
          <a:graphicData uri="http://schemas.openxmlformats.org/drawingml/2006/table">
            <a:tbl>
              <a:tblPr firstRow="1" firstCol="1" bandRow="1"/>
              <a:tblGrid>
                <a:gridCol w="1219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81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14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953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Strain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Recombinant region (nucleotides)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Parental Strain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% Similarity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441SA1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-4066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470SA1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00%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4067-17167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Unknown (Probable 355SA13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7168-18039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470SA1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00%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451SA1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-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Unknown (Probable 355SA13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2-5635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470SA15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100%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5636-18039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Unknown (Probable 355SA13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31968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43</Words>
  <Application>Microsoft Office PowerPoint</Application>
  <PresentationFormat>Custom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e</dc:creator>
  <cp:lastModifiedBy>Jae</cp:lastModifiedBy>
  <cp:revision>26</cp:revision>
  <dcterms:created xsi:type="dcterms:W3CDTF">2016-05-02T07:04:11Z</dcterms:created>
  <dcterms:modified xsi:type="dcterms:W3CDTF">2016-07-12T23:14:06Z</dcterms:modified>
</cp:coreProperties>
</file>